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19.png" ContentType="image/png"/>
  <Override PartName="/ppt/media/image1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D2321-4953-4720-9F78-222818F97E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55A98C-CD30-4BCA-B0D0-D6B651A61B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2A483-7F8C-4F9E-84C0-E6AB566423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18F0A-9C1D-4433-ADCA-5DEDBE6706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D70999-D5FA-4B8A-8449-16C36A0EA8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02DEA-6E89-4415-BED9-76274A2E3D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6C167-3079-44EB-9AD2-D992703816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AAD84-3F9A-471C-90B2-9505B40ADF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644EE-F668-4AC5-8AE9-F9DF2502ED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C5584-CD2C-451D-A322-E60A82ED3A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EDB7F-9904-4E80-BD8B-6C67E81FE5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7A7F22-D46A-4D2A-BAC4-55ACB614B1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AAFC2B-7124-4943-9DAE-42020DECF2F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8440" y="228600"/>
            <a:ext cx="1541520" cy="14619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66600" y="3571920"/>
            <a:ext cx="1501920" cy="146196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0" y="5243400"/>
            <a:ext cx="1582560" cy="14623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82520" y="2422440"/>
            <a:ext cx="1276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UNX2 not pres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 U133A ch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4"/>
          <a:stretch/>
        </p:blipFill>
        <p:spPr>
          <a:xfrm>
            <a:off x="1565280" y="228600"/>
            <a:ext cx="1541520" cy="146196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5"/>
          <a:stretch/>
        </p:blipFill>
        <p:spPr>
          <a:xfrm>
            <a:off x="1565280" y="1981080"/>
            <a:ext cx="1541520" cy="146232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6"/>
          <a:stretch/>
        </p:blipFill>
        <p:spPr>
          <a:xfrm>
            <a:off x="1593720" y="5243400"/>
            <a:ext cx="1501920" cy="146232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7"/>
          <a:stretch/>
        </p:blipFill>
        <p:spPr>
          <a:xfrm>
            <a:off x="4613400" y="228600"/>
            <a:ext cx="1501560" cy="146196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8"/>
          <a:stretch/>
        </p:blipFill>
        <p:spPr>
          <a:xfrm>
            <a:off x="4613400" y="1981080"/>
            <a:ext cx="1501560" cy="146232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9"/>
          <a:stretch/>
        </p:blipFill>
        <p:spPr>
          <a:xfrm>
            <a:off x="4613400" y="3581280"/>
            <a:ext cx="1501560" cy="146232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10"/>
          <a:stretch/>
        </p:blipFill>
        <p:spPr>
          <a:xfrm>
            <a:off x="4595760" y="5243400"/>
            <a:ext cx="1541520" cy="146232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11"/>
          <a:stretch/>
        </p:blipFill>
        <p:spPr>
          <a:xfrm>
            <a:off x="3094200" y="228600"/>
            <a:ext cx="1501560" cy="146196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12"/>
          <a:stretch/>
        </p:blipFill>
        <p:spPr>
          <a:xfrm>
            <a:off x="3094200" y="1981080"/>
            <a:ext cx="1501560" cy="146232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13"/>
          <a:stretch/>
        </p:blipFill>
        <p:spPr>
          <a:xfrm>
            <a:off x="3054240" y="3581280"/>
            <a:ext cx="1541520" cy="146232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3166560" y="5715000"/>
            <a:ext cx="1269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EMD1 not pres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 U133A ch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681200" y="4038480"/>
            <a:ext cx="1179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TX2 not pres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 U133A ch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14"/>
          <a:stretch/>
        </p:blipFill>
        <p:spPr>
          <a:xfrm>
            <a:off x="6103800" y="228600"/>
            <a:ext cx="1541520" cy="146196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15"/>
          <a:stretch/>
        </p:blipFill>
        <p:spPr>
          <a:xfrm>
            <a:off x="6141960" y="1981080"/>
            <a:ext cx="1501920" cy="146232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16"/>
          <a:stretch/>
        </p:blipFill>
        <p:spPr>
          <a:xfrm>
            <a:off x="6149880" y="3581280"/>
            <a:ext cx="1501920" cy="146232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6256800" y="5715000"/>
            <a:ext cx="1305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F179 not pres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 U133A ch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17"/>
          <a:srcRect l="0" t="0" r="5566" b="0"/>
          <a:stretch/>
        </p:blipFill>
        <p:spPr>
          <a:xfrm>
            <a:off x="7634160" y="228600"/>
            <a:ext cx="1457280" cy="146196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18"/>
          <a:srcRect l="0" t="0" r="5566" b="0"/>
          <a:stretch/>
        </p:blipFill>
        <p:spPr>
          <a:xfrm>
            <a:off x="7634160" y="1981080"/>
            <a:ext cx="1457280" cy="146232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19"/>
          <a:srcRect l="0" t="0" r="5704" b="0"/>
          <a:stretch/>
        </p:blipFill>
        <p:spPr>
          <a:xfrm>
            <a:off x="7674120" y="5243400"/>
            <a:ext cx="1417320" cy="146232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7717680" y="4098960"/>
            <a:ext cx="12553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TPN5 not pres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 U133A ch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8440" y="28440"/>
            <a:ext cx="1467000" cy="6753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546200" y="28440"/>
            <a:ext cx="1467000" cy="6753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071880" y="28440"/>
            <a:ext cx="1466640" cy="6753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595760" y="28440"/>
            <a:ext cx="1467000" cy="6753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6127920" y="28440"/>
            <a:ext cx="1466640" cy="6753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7651800" y="28440"/>
            <a:ext cx="1466640" cy="6753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1920" y="33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550880" y="33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133440" y="33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581360" y="33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189480" y="3348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637760" y="3348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31T11:53:47Z</dcterms:created>
  <dc:creator>marcelk</dc:creator>
  <dc:description/>
  <dc:language>en-US</dc:language>
  <cp:lastModifiedBy>marcelk</cp:lastModifiedBy>
  <dcterms:modified xsi:type="dcterms:W3CDTF">2008-02-15T13:45:44Z</dcterms:modified>
  <cp:revision>2</cp:revision>
  <dc:subject/>
  <dc:title>Slide 1</dc:title>
</cp:coreProperties>
</file>